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1" r:id="rId4"/>
    <p:sldId id="257" r:id="rId5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300" y="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17E3D-B590-47A0-9194-DF332AAD1F5D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0E13D-92AD-4631-96AD-43751F94BBA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5195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17E3D-B590-47A0-9194-DF332AAD1F5D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0E13D-92AD-4631-96AD-43751F94BBA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51419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17E3D-B590-47A0-9194-DF332AAD1F5D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0E13D-92AD-4631-96AD-43751F94BBA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70378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17E3D-B590-47A0-9194-DF332AAD1F5D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0E13D-92AD-4631-96AD-43751F94BBA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23400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17E3D-B590-47A0-9194-DF332AAD1F5D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0E13D-92AD-4631-96AD-43751F94BBA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6871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17E3D-B590-47A0-9194-DF332AAD1F5D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0E13D-92AD-4631-96AD-43751F94BBA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22761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17E3D-B590-47A0-9194-DF332AAD1F5D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0E13D-92AD-4631-96AD-43751F94BBA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64600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17E3D-B590-47A0-9194-DF332AAD1F5D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0E13D-92AD-4631-96AD-43751F94BBA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50398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17E3D-B590-47A0-9194-DF332AAD1F5D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0E13D-92AD-4631-96AD-43751F94BBA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29565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17E3D-B590-47A0-9194-DF332AAD1F5D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0E13D-92AD-4631-96AD-43751F94BBA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94035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17E3D-B590-47A0-9194-DF332AAD1F5D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0E13D-92AD-4631-96AD-43751F94BBA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8925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B17E3D-B590-47A0-9194-DF332AAD1F5D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D0E13D-92AD-4631-96AD-43751F94BBA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734571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692" y="579497"/>
            <a:ext cx="4091121" cy="518122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1798" y="579497"/>
            <a:ext cx="4156362" cy="518122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1658" y="579497"/>
            <a:ext cx="3922346" cy="518122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10588" y="6142375"/>
            <a:ext cx="49961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: Survey questions for AOF children </a:t>
            </a:r>
          </a:p>
        </p:txBody>
      </p:sp>
    </p:spTree>
    <p:extLst>
      <p:ext uri="{BB962C8B-B14F-4D97-AF65-F5344CB8AC3E}">
        <p14:creationId xmlns:p14="http://schemas.microsoft.com/office/powerpoint/2010/main" val="1507907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443" y="152130"/>
            <a:ext cx="4402339" cy="539496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8835" y="245189"/>
            <a:ext cx="5141660" cy="539495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24443" y="6275379"/>
            <a:ext cx="49961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: Survey questions for AOF children </a:t>
            </a:r>
          </a:p>
        </p:txBody>
      </p:sp>
    </p:spTree>
    <p:extLst>
      <p:ext uri="{BB962C8B-B14F-4D97-AF65-F5344CB8AC3E}">
        <p14:creationId xmlns:p14="http://schemas.microsoft.com/office/powerpoint/2010/main" val="6013853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8187" y="264024"/>
            <a:ext cx="4289096" cy="558768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054453" y="6086354"/>
            <a:ext cx="5600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3: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Consent form for participation in the study </a:t>
            </a:r>
          </a:p>
        </p:txBody>
      </p:sp>
    </p:spTree>
    <p:extLst>
      <p:ext uri="{BB962C8B-B14F-4D97-AF65-F5344CB8AC3E}">
        <p14:creationId xmlns:p14="http://schemas.microsoft.com/office/powerpoint/2010/main" val="30847083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/>
          </p:nvPr>
        </p:nvGraphicFramePr>
        <p:xfrm>
          <a:off x="445273" y="429487"/>
          <a:ext cx="2894275" cy="1736725"/>
        </p:xfrm>
        <a:graphic>
          <a:graphicData uri="http://schemas.openxmlformats.org/drawingml/2006/table">
            <a:tbl>
              <a:tblPr/>
              <a:tblGrid>
                <a:gridCol w="204428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499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2415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120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Parameters 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CA" sz="120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Curtain gas 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35 psi 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Temperature 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700 ˚C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Ion Source Gas 1 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0 psi 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Ion Source Gas 2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55psi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Collision Gas 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Medium 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Ionspray Voltage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5000</a:t>
                      </a:r>
                      <a:endParaRPr lang="en-CA" sz="1200" dirty="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61434" y="183265"/>
            <a:ext cx="4871655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4: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ositive ESI condition of mass spectrometer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/>
          </p:nvPr>
        </p:nvGraphicFramePr>
        <p:xfrm>
          <a:off x="5822288" y="753116"/>
          <a:ext cx="5453380" cy="1184910"/>
        </p:xfrm>
        <a:graphic>
          <a:graphicData uri="http://schemas.openxmlformats.org/drawingml/2006/table">
            <a:tbl>
              <a:tblPr firstRow="1" firstCol="1" bandRow="1"/>
              <a:tblGrid>
                <a:gridCol w="17316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5758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6230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7945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39395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alyte&amp;Internal</a:t>
                      </a:r>
                      <a:r>
                        <a:rPr lang="en-CA" sz="12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STD</a:t>
                      </a:r>
                      <a:endParaRPr lang="en-CA" sz="1200" dirty="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RM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ansitions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P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P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XP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3515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V)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V)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eV)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V)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rtisol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63/121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63/327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rtisol-d4</a:t>
                      </a:r>
                      <a:endParaRPr lang="en-CA" sz="1200" dirty="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67/121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67/331</a:t>
                      </a:r>
                      <a:endParaRPr lang="en-CA" sz="1200" dirty="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5679950" y="233899"/>
            <a:ext cx="6513130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5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RM conditions in positive ESI mode. (DP=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eclusterin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otential,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P= entrance potential, CE= collision energy, and CXP= collision cell exit potential)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/>
          </p:nvPr>
        </p:nvGraphicFramePr>
        <p:xfrm>
          <a:off x="345448" y="3503336"/>
          <a:ext cx="1905000" cy="2837815"/>
        </p:xfrm>
        <a:graphic>
          <a:graphicData uri="http://schemas.openxmlformats.org/drawingml/2006/table">
            <a:tbl>
              <a:tblPr firstRow="1" firstCol="1" bandRow="1"/>
              <a:tblGrid>
                <a:gridCol w="8382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99415">
                <a:tc>
                  <a:txBody>
                    <a:bodyPr/>
                    <a:lstStyle/>
                    <a:p>
                      <a:endParaRPr lang="en-CA" sz="1200" dirty="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rtisol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ng/mL)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l 1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l 2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l 3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l 4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l 5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l 6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l 7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CA" sz="1200" dirty="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l 8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l 9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l 10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l 11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l 12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en-CA" sz="1200" dirty="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200848" y="2771165"/>
            <a:ext cx="5132944" cy="12311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6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centrations (ng/mL) of calibrators prepared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Methanol:H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 (50/50, v/v). R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 of all calibration curves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re greater than 0.99.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Table 11"/>
          <p:cNvGraphicFramePr>
            <a:graphicFrameLocks noGrp="1"/>
          </p:cNvGraphicFramePr>
          <p:nvPr>
            <p:extLst/>
          </p:nvPr>
        </p:nvGraphicFramePr>
        <p:xfrm>
          <a:off x="6740718" y="3380465"/>
          <a:ext cx="3870960" cy="400050"/>
        </p:xfrm>
        <a:graphic>
          <a:graphicData uri="http://schemas.openxmlformats.org/drawingml/2006/table">
            <a:tbl>
              <a:tblPr firstRow="1" firstCol="1" bandRow="1"/>
              <a:tblGrid>
                <a:gridCol w="20701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0086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alyte</a:t>
                      </a:r>
                      <a:endParaRPr lang="en-CA" sz="1200" dirty="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LOQ (ng/mL)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rtisol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CA" sz="1200" dirty="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6740718" y="3041911"/>
            <a:ext cx="3821111" cy="6771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7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LOQ of Targeted Steroids.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4" name="Table 13"/>
          <p:cNvGraphicFramePr>
            <a:graphicFrameLocks noGrp="1"/>
          </p:cNvGraphicFramePr>
          <p:nvPr>
            <p:extLst/>
          </p:nvPr>
        </p:nvGraphicFramePr>
        <p:xfrm>
          <a:off x="6217861" y="5117207"/>
          <a:ext cx="5260975" cy="586105"/>
        </p:xfrm>
        <a:graphic>
          <a:graphicData uri="http://schemas.openxmlformats.org/drawingml/2006/table">
            <a:tbl>
              <a:tblPr firstRow="1" firstCol="1" bandRow="1"/>
              <a:tblGrid>
                <a:gridCol w="166306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9888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9951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9951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7655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mpounds</a:t>
                      </a:r>
                      <a:endParaRPr lang="en-CA" sz="1200" dirty="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igh QC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ng/mL)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id QC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ng/mL)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w QC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ng/mL)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rtisol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CA" sz="120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CA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CA" sz="1200" dirty="0">
                        <a:effectLst/>
                        <a:latin typeface="Cambria" panose="020405030504060302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6141720" y="4773560"/>
            <a:ext cx="3906647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Table 8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pected QC concentrations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7769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9</TotalTime>
  <Words>263</Words>
  <Application>Microsoft Office PowerPoint</Application>
  <PresentationFormat>Widescreen</PresentationFormat>
  <Paragraphs>9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Cambri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shad</dc:creator>
  <cp:lastModifiedBy>Muhammad Arshad</cp:lastModifiedBy>
  <cp:revision>14</cp:revision>
  <cp:lastPrinted>2018-10-17T21:40:03Z</cp:lastPrinted>
  <dcterms:created xsi:type="dcterms:W3CDTF">2018-06-01T20:58:56Z</dcterms:created>
  <dcterms:modified xsi:type="dcterms:W3CDTF">2019-03-13T20:47:26Z</dcterms:modified>
</cp:coreProperties>
</file>